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62" r:id="rId4"/>
    <p:sldId id="258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B01086-B3C9-49C8-A90A-41A7A23CD38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6153E5-46F9-49DB-9B16-17677309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1473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6153E5-46F9-49DB-9B16-1767730930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1099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6153E5-46F9-49DB-9B16-17677309305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5262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6153E5-46F9-49DB-9B16-17677309305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7115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6153E5-46F9-49DB-9B16-17677309305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7961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6153E5-46F9-49DB-9B16-17677309305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11354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6153E5-46F9-49DB-9B16-17677309305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2812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189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73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97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560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46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877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113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632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172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022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555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061F4-5C35-47F0-B6CC-C71818F9BF6E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24B41-0510-4B8B-925A-B6584980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91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Transcriptomic Markers of Recombinant Human Erythropoietin Micro-Dosing in Thoroughbred Horse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495800"/>
            <a:ext cx="6400800" cy="1752600"/>
          </a:xfrm>
        </p:spPr>
        <p:txBody>
          <a:bodyPr/>
          <a:lstStyle/>
          <a:p>
            <a:r>
              <a:rPr lang="en-US" dirty="0"/>
              <a:t>Supplemental Tables and Figures</a:t>
            </a:r>
          </a:p>
        </p:txBody>
      </p:sp>
    </p:spTree>
    <p:extLst>
      <p:ext uri="{BB962C8B-B14F-4D97-AF65-F5344CB8AC3E}">
        <p14:creationId xmlns:p14="http://schemas.microsoft.com/office/powerpoint/2010/main" val="3034708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ble S1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2967685"/>
              </p:ext>
            </p:extLst>
          </p:nvPr>
        </p:nvGraphicFramePr>
        <p:xfrm>
          <a:off x="1524000" y="1447800"/>
          <a:ext cx="6146800" cy="4040124"/>
        </p:xfrm>
        <a:graphic>
          <a:graphicData uri="http://schemas.openxmlformats.org/drawingml/2006/table">
            <a:tbl>
              <a:tblPr firstRow="1" bandRow="1"/>
              <a:tblGrid>
                <a:gridCol w="11196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103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2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280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0840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able S1: </a:t>
                      </a:r>
                      <a:r>
                        <a:rPr lang="en-US" sz="11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imer sequences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Transcript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Coordinates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Forward Sequen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Reverse Sequen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C13H16orf5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chr13:20,454,043-20,454,70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CAGCATGATGGGGATACAGG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AGAGAGGAGCCCAGGACTGA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PUM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chr15:76,186,319-76,188,17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CTGCTGAGCGACAAATGGTA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TGACCACGAATACGAGTAGC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CHTOP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chr5:40,507,416-40,508,838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GCATCGGCTGTTTGTTCTT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AGTCAGCGCCGAAAGTTG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B2M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chr1:145,961,343-145,964,67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Times New Roman"/>
                        </a:rPr>
                        <a:t>TCGGGCTACTCTCCCTGACT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GTGAGTAAACCTGAACCTTCG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10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3:4,382,919-4,383,011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GAGAAGCTCTGCTATGTCG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CAGCTCGTAGCTCTTC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336237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1</a:t>
            </a: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524000" y="6020544"/>
            <a:ext cx="6477000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1. 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omplete blood count results of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A) </a:t>
            </a:r>
            <a:r>
              <a:rPr lang="en-US" altLang="en-US" sz="1000" i="0" dirty="0">
                <a:latin typeface="Arial" pitchFamily="34" charset="0"/>
                <a:ea typeface="Calibri" pitchFamily="34" charset="0"/>
                <a:cs typeface="Arial" pitchFamily="34" charset="0"/>
              </a:rPr>
              <a:t>red blood cell</a:t>
            </a:r>
            <a:r>
              <a:rPr lang="en-US" alt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s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,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(B) </a:t>
            </a: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hemoglobin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,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nd (C) </a:t>
            </a: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hematocrit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cross time points (in </a:t>
            </a:r>
            <a:r>
              <a:rPr lang="en-US" alt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days Each data point is an individual horse with saline treatment as teal and EPO-dosed horses as purple.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here is no overall significant difference effect of treatment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B6DF94B-04BC-435B-9B86-CFE1A83D08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0" y="1043816"/>
            <a:ext cx="7543800" cy="4899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6440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2</a:t>
            </a: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2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7919" y="1676400"/>
            <a:ext cx="7048163" cy="3403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501127" y="5181600"/>
            <a:ext cx="7957073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S2.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Multidimensional scaling (MDS) plots of read counts normalized by </a:t>
            </a:r>
            <a:r>
              <a:rPr kumimoji="0" lang="en-US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EdgeR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(A) MDS plot indicating time point by shape and treatment group by color. (B) MDS plot showing each individual horse (denoted by each individuals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ea typeface="Times New Roman" pitchFamily="18" charset="0"/>
                <a:cs typeface="Arial" pitchFamily="34" charset="0"/>
              </a:rPr>
              <a:t>’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numbers)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2368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</a:t>
            </a: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524000" y="5943600"/>
            <a:ext cx="6477000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3.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PMs transformed by log</a:t>
            </a:r>
            <a:r>
              <a:rPr kumimoji="0" lang="en-US" altLang="en-US" sz="10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2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CPM+1) of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A)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13H16orf54,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(B)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PUM2,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nd (C)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HTOP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cross five time points (in days) from RNA-seq. Each data point is an individual horse with saline treatment as teal and EPO-dosed horses as purple. There is a significant difference between treatment groups at 7 days for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13H16orf54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nd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HTOP. * P</a:t>
            </a:r>
            <a:r>
              <a:rPr kumimoji="0" lang="en-US" altLang="en-US" sz="10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DR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&lt;0.05, **P</a:t>
            </a:r>
            <a:r>
              <a:rPr kumimoji="0" lang="en-US" altLang="en-US" sz="10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DR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&lt;0.01, ****P</a:t>
            </a:r>
            <a:r>
              <a:rPr kumimoji="0" lang="en-US" altLang="en-US" sz="10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DR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&lt;0.0001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7" name="Picture 2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4933" y="1543050"/>
            <a:ext cx="6614135" cy="4343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641189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4</a:t>
            </a: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524000" y="5943600"/>
            <a:ext cx="6477000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4. </a:t>
            </a:r>
            <a:r>
              <a:rPr lang="en-US" altLang="en-US" sz="1000" dirty="0">
                <a:latin typeface="Arial" pitchFamily="34" charset="0"/>
                <a:ea typeface="Calibri" pitchFamily="34" charset="0"/>
                <a:cs typeface="Arial" pitchFamily="34" charset="0"/>
              </a:rPr>
              <a:t>Non-zero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PMs transformed by log</a:t>
            </a:r>
            <a:r>
              <a:rPr kumimoji="0" lang="en-US" altLang="en-US" sz="10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2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CPM+1) of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A)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13H16orf54,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(B)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PUM2,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nd (C)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HTOP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cross time points (in days) from RNA-seq. Each data point is an individual horse with saline treatment as teal and EPO-dosed horses as purple. There is no significant difference between treatment groups at any time point with non-zero values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489990F-BBD3-4FAC-9AE8-08554C4F7A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3866" y="1017905"/>
            <a:ext cx="7296269" cy="4822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0935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3</TotalTime>
  <Words>329</Words>
  <Application>Microsoft Office PowerPoint</Application>
  <PresentationFormat>On-screen Show (4:3)</PresentationFormat>
  <Paragraphs>42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Transcriptomic Markers of Recombinant Human Erythropoietin Micro-Dosing in Thoroughbred Horses</vt:lpstr>
      <vt:lpstr>Table S1</vt:lpstr>
      <vt:lpstr>Figure S1</vt:lpstr>
      <vt:lpstr>Figure S2</vt:lpstr>
      <vt:lpstr>Figure S3</vt:lpstr>
      <vt:lpstr>Figure S4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nscriptomic Markers of Recombinant Human Erythropoietin Micro-Dosing in Thoroughbred Horses</dc:title>
  <dc:creator>Anna</dc:creator>
  <cp:lastModifiedBy>Finno, Carrie</cp:lastModifiedBy>
  <cp:revision>17</cp:revision>
  <dcterms:created xsi:type="dcterms:W3CDTF">2021-09-16T19:22:57Z</dcterms:created>
  <dcterms:modified xsi:type="dcterms:W3CDTF">2021-11-22T16:09:47Z</dcterms:modified>
</cp:coreProperties>
</file>